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bin" ContentType="application/vnd.openxmlformats-officedocument.oleObject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  <p:sldId id="266" r:id="rId4"/>
    <p:sldId id="265" r:id="rId5"/>
    <p:sldId id="263" r:id="rId6"/>
  </p:sldIdLst>
  <p:sldSz cx="6858000" cy="12192000"/>
  <p:notesSz cx="6797675" cy="9926638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onneveld, Myrthe" initials="SM" lastIdx="1" clrIdx="0">
    <p:extLst>
      <p:ext uri="{19B8F6BF-5375-455C-9EA6-DF929625EA0E}">
        <p15:presenceInfo xmlns:p15="http://schemas.microsoft.com/office/powerpoint/2012/main" userId="S-1-5-21-3253110828-3739289402-1749108967-8119" providerId="AD"/>
      </p:ext>
    </p:extLst>
  </p:cmAuthor>
  <p:cmAuthor id="2" name="Plomp, H.R. (PARA)" initials="hr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703" autoAdjust="0"/>
    <p:restoredTop sz="94660"/>
  </p:normalViewPr>
  <p:slideViewPr>
    <p:cSldViewPr snapToGrid="0">
      <p:cViewPr varScale="1">
        <p:scale>
          <a:sx n="42" d="100"/>
          <a:sy n="42" d="100"/>
        </p:scale>
        <p:origin x="2652" y="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74955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34074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65516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73787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70627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38969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72250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39147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85673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08883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87258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045437-B392-45F8-A7CC-763184262F10}" type="datetimeFigureOut">
              <a:rPr lang="nl-NL" smtClean="0"/>
              <a:t>4-9-2017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78105-A13B-4552-8849-02D589FF2E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81382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514350" y="1995312"/>
            <a:ext cx="5829300" cy="1396474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dirty="0"/>
              <a:t>Supplementary file ‘</a:t>
            </a:r>
            <a:r>
              <a:rPr lang="en-US" sz="2000" dirty="0" smtClean="0"/>
              <a:t>’IgG1 </a:t>
            </a:r>
            <a:r>
              <a:rPr lang="en-US" sz="2000" dirty="0"/>
              <a:t>and IgG3 have similar glycosylation levels in immune responses’’</a:t>
            </a:r>
            <a:endParaRPr lang="nl-NL" sz="2000" dirty="0"/>
          </a:p>
        </p:txBody>
      </p:sp>
      <p:sp>
        <p:nvSpPr>
          <p:cNvPr id="6" name="Subtitle 2"/>
          <p:cNvSpPr txBox="1">
            <a:spLocks/>
          </p:cNvSpPr>
          <p:nvPr/>
        </p:nvSpPr>
        <p:spPr>
          <a:xfrm>
            <a:off x="857250" y="3522200"/>
            <a:ext cx="5143500" cy="2943577"/>
          </a:xfrm>
          <a:prstGeom prst="rect">
            <a:avLst/>
          </a:prstGeom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nl-NL" sz="1600" dirty="0"/>
              <a:t>Myrthe E. Sonneveld</a:t>
            </a:r>
            <a:r>
              <a:rPr lang="nl-NL" sz="1600" baseline="30000" dirty="0"/>
              <a:t>1</a:t>
            </a:r>
            <a:r>
              <a:rPr lang="nl-NL" sz="1600" dirty="0"/>
              <a:t>, Carolien </a:t>
            </a:r>
            <a:r>
              <a:rPr lang="nl-NL" sz="1600" dirty="0" smtClean="0"/>
              <a:t>A.M. Koeleman</a:t>
            </a:r>
            <a:r>
              <a:rPr lang="nl-NL" sz="1600" baseline="30000" dirty="0" smtClean="0"/>
              <a:t>2</a:t>
            </a:r>
            <a:r>
              <a:rPr lang="nl-NL" sz="1600" dirty="0"/>
              <a:t>, </a:t>
            </a:r>
            <a:r>
              <a:rPr lang="nl-NL" sz="1600" dirty="0" smtClean="0"/>
              <a:t>H. </a:t>
            </a:r>
            <a:r>
              <a:rPr lang="nl-NL" sz="1600" dirty="0" err="1" smtClean="0"/>
              <a:t>Rosina</a:t>
            </a:r>
            <a:r>
              <a:rPr lang="nl-NL" sz="1600" dirty="0" smtClean="0"/>
              <a:t> Plomp</a:t>
            </a:r>
            <a:r>
              <a:rPr lang="nl-NL" sz="1600" baseline="30000" dirty="0" smtClean="0"/>
              <a:t>2,</a:t>
            </a:r>
            <a:r>
              <a:rPr lang="nl-NL" sz="1600" dirty="0" smtClean="0"/>
              <a:t> Manfred </a:t>
            </a:r>
            <a:r>
              <a:rPr lang="nl-NL" sz="1600" dirty="0"/>
              <a:t>Wuhrer</a:t>
            </a:r>
            <a:r>
              <a:rPr lang="nl-NL" sz="1600" baseline="30000" dirty="0"/>
              <a:t>2</a:t>
            </a:r>
            <a:r>
              <a:rPr lang="nl-NL" sz="1600" dirty="0"/>
              <a:t>, C. Ellen van der Schoot</a:t>
            </a:r>
            <a:r>
              <a:rPr lang="nl-NL" sz="1600" baseline="30000" dirty="0"/>
              <a:t>1</a:t>
            </a:r>
            <a:r>
              <a:rPr lang="nl-NL" sz="1600" dirty="0"/>
              <a:t>, </a:t>
            </a:r>
            <a:r>
              <a:rPr lang="nl-NL" sz="1600" dirty="0" err="1"/>
              <a:t>Gestur</a:t>
            </a:r>
            <a:r>
              <a:rPr lang="nl-NL" sz="1600" dirty="0"/>
              <a:t> Vidarsson</a:t>
            </a:r>
            <a:r>
              <a:rPr lang="nl-NL" sz="1600" baseline="30000" dirty="0"/>
              <a:t>1</a:t>
            </a:r>
            <a:r>
              <a:rPr lang="nl-NL" sz="1600" dirty="0"/>
              <a:t>.</a:t>
            </a:r>
          </a:p>
          <a:p>
            <a:pPr marL="0" indent="0" algn="ctr">
              <a:buNone/>
            </a:pPr>
            <a:r>
              <a:rPr lang="en-US" sz="1200" dirty="0"/>
              <a:t>1 Department of Experimental Immunohematology, </a:t>
            </a:r>
            <a:r>
              <a:rPr lang="en-US" sz="1200" dirty="0" err="1"/>
              <a:t>Sanquin</a:t>
            </a:r>
            <a:r>
              <a:rPr lang="en-US" sz="1200" dirty="0"/>
              <a:t> Research, Amsterdam, and Landsteiner Laboratory, Academic Medical Centre, University of Amsterdam, Amsterdam, The Netherlands; 2 Center for Proteomics and Metabolomics, Leiden University Medical Center, Leiden, The Netherlands.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9655589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2606654"/>
              </p:ext>
            </p:extLst>
          </p:nvPr>
        </p:nvGraphicFramePr>
        <p:xfrm>
          <a:off x="520701" y="1361070"/>
          <a:ext cx="5665382" cy="16551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8" name="Prism 6" r:id="rId3" imgW="5599750" imgH="1635820" progId="Prism6.Document">
                  <p:embed/>
                </p:oleObj>
              </mc:Choice>
              <mc:Fallback>
                <p:oleObj name="Prism 6" r:id="rId3" imgW="5599750" imgH="16358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0701" y="1361070"/>
                        <a:ext cx="5665382" cy="16551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itle 1"/>
          <p:cNvSpPr txBox="1">
            <a:spLocks/>
          </p:cNvSpPr>
          <p:nvPr/>
        </p:nvSpPr>
        <p:spPr>
          <a:xfrm>
            <a:off x="471488" y="649114"/>
            <a:ext cx="5915025" cy="6799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800" dirty="0"/>
              <a:t>Sonneveld et al. </a:t>
            </a:r>
            <a:r>
              <a:rPr lang="nl-NL" sz="1800" dirty="0" err="1"/>
              <a:t>Supplementary</a:t>
            </a:r>
            <a:r>
              <a:rPr lang="nl-NL" sz="1800" dirty="0"/>
              <a:t> </a:t>
            </a:r>
            <a:r>
              <a:rPr lang="nl-NL" sz="1800" dirty="0" err="1"/>
              <a:t>figure</a:t>
            </a:r>
            <a:r>
              <a:rPr lang="nl-NL" sz="1800" dirty="0"/>
              <a:t> 1</a:t>
            </a: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471488" y="1200290"/>
            <a:ext cx="312950" cy="3260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800" dirty="0"/>
              <a:t>A</a:t>
            </a:r>
          </a:p>
        </p:txBody>
      </p:sp>
      <p:sp>
        <p:nvSpPr>
          <p:cNvPr id="13" name="Title 1"/>
          <p:cNvSpPr txBox="1">
            <a:spLocks/>
          </p:cNvSpPr>
          <p:nvPr/>
        </p:nvSpPr>
        <p:spPr>
          <a:xfrm>
            <a:off x="467413" y="2852763"/>
            <a:ext cx="312950" cy="3260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800" dirty="0"/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95677" y="4572359"/>
            <a:ext cx="591502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upplemental </a:t>
            </a:r>
            <a:r>
              <a:rPr lang="en-US" sz="1100" b="1" dirty="0"/>
              <a:t>figure </a:t>
            </a:r>
            <a:r>
              <a:rPr lang="en-US" sz="1100" b="1" dirty="0" smtClean="0"/>
              <a:t>1 Minimal differences in Fc-glycosylation between IgG1 and IgG3 except for sialylation. </a:t>
            </a:r>
            <a:r>
              <a:rPr lang="en-US" sz="1100" dirty="0" smtClean="0"/>
              <a:t>Total (A) and anti-K (B) Fc-glycosylation </a:t>
            </a:r>
            <a:r>
              <a:rPr lang="en-US" sz="1100" dirty="0"/>
              <a:t>(y-axis) was compared for IgG1 and IgG3 subclasses (x-axis), showing for (A) total IgG a minimal lower </a:t>
            </a:r>
            <a:r>
              <a:rPr lang="en-US" sz="1100" dirty="0" err="1" smtClean="0"/>
              <a:t>fucosylation</a:t>
            </a:r>
            <a:r>
              <a:rPr lang="en-US" sz="1100" dirty="0" smtClean="0"/>
              <a:t> and bisection for </a:t>
            </a:r>
            <a:r>
              <a:rPr lang="en-US" sz="1100" dirty="0"/>
              <a:t>IgG3 compared to IgG1 and a higher </a:t>
            </a:r>
            <a:r>
              <a:rPr lang="en-US" sz="1100" dirty="0" smtClean="0"/>
              <a:t>sialylation (</a:t>
            </a:r>
            <a:r>
              <a:rPr lang="en-US" sz="1100" dirty="0"/>
              <a:t>mean 90% vs. 91</a:t>
            </a:r>
            <a:r>
              <a:rPr lang="en-US" sz="1100" dirty="0" smtClean="0"/>
              <a:t>%, 13.3% vs. 12.8% and 12 vs. 16% resp.). (B) Anti-K </a:t>
            </a:r>
            <a:r>
              <a:rPr lang="en-US" sz="1100" dirty="0"/>
              <a:t>shows a higher </a:t>
            </a:r>
            <a:r>
              <a:rPr lang="en-US" sz="1100" dirty="0" smtClean="0"/>
              <a:t>bisection and sialylation </a:t>
            </a:r>
            <a:r>
              <a:rPr lang="en-US" sz="1100" dirty="0"/>
              <a:t>for IgG3 compared to </a:t>
            </a:r>
            <a:r>
              <a:rPr lang="en-US" sz="1100" dirty="0" smtClean="0"/>
              <a:t>IgG1 (19% vs. 25% and 11% vs. 15% resp.) while anti-K </a:t>
            </a:r>
            <a:r>
              <a:rPr lang="en-US" sz="1100" dirty="0"/>
              <a:t>specific antibodies were comparable for IgG1 and IgG3-anti-K </a:t>
            </a:r>
            <a:r>
              <a:rPr lang="en-US" sz="1100" dirty="0" err="1"/>
              <a:t>galactosylation</a:t>
            </a:r>
            <a:r>
              <a:rPr lang="en-US" sz="1100" dirty="0"/>
              <a:t> (mean IgG1 62% and IgG3 61</a:t>
            </a:r>
            <a:r>
              <a:rPr lang="en-US" sz="1100" dirty="0" smtClean="0"/>
              <a:t>%) and </a:t>
            </a:r>
            <a:r>
              <a:rPr lang="en-US" sz="1100" dirty="0" err="1"/>
              <a:t>fucosylation</a:t>
            </a:r>
            <a:r>
              <a:rPr lang="en-US" sz="1100" dirty="0"/>
              <a:t> (69% vs. 68</a:t>
            </a:r>
            <a:r>
              <a:rPr lang="en-US" sz="1100" dirty="0" smtClean="0"/>
              <a:t>%). Statistical </a:t>
            </a:r>
            <a:r>
              <a:rPr lang="en-US" sz="1100" dirty="0"/>
              <a:t>analysis was done using paired t-testing</a:t>
            </a:r>
            <a:r>
              <a:rPr lang="en-US" sz="1100" dirty="0" smtClean="0"/>
              <a:t>.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8070590"/>
              </p:ext>
            </p:extLst>
          </p:nvPr>
        </p:nvGraphicFramePr>
        <p:xfrm>
          <a:off x="569406" y="2928551"/>
          <a:ext cx="5616676" cy="16449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9" name="Prism 7" r:id="rId5" imgW="6967186" imgH="2039912" progId="Prism7.Document">
                  <p:embed/>
                </p:oleObj>
              </mc:Choice>
              <mc:Fallback>
                <p:oleObj name="Prism 7" r:id="rId5" imgW="6967186" imgH="203991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69406" y="2928551"/>
                        <a:ext cx="5616676" cy="16449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11305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 txBox="1">
            <a:spLocks/>
          </p:cNvSpPr>
          <p:nvPr/>
        </p:nvSpPr>
        <p:spPr>
          <a:xfrm>
            <a:off x="471488" y="649114"/>
            <a:ext cx="5915025" cy="6799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800" dirty="0"/>
              <a:t>Sonneveld et al. </a:t>
            </a:r>
            <a:r>
              <a:rPr lang="nl-NL" sz="1800" dirty="0" err="1"/>
              <a:t>Supplementary</a:t>
            </a:r>
            <a:r>
              <a:rPr lang="nl-NL" sz="1800" dirty="0"/>
              <a:t> </a:t>
            </a:r>
            <a:r>
              <a:rPr lang="nl-NL" sz="1800" dirty="0" err="1" smtClean="0"/>
              <a:t>table</a:t>
            </a:r>
            <a:r>
              <a:rPr lang="nl-NL" sz="1800" dirty="0" smtClean="0"/>
              <a:t> </a:t>
            </a:r>
            <a:r>
              <a:rPr lang="nl-NL" sz="1800" dirty="0"/>
              <a:t>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69338" y="10961475"/>
            <a:ext cx="6425076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Supplementary table 1 </a:t>
            </a:r>
            <a:r>
              <a:rPr lang="en-US" sz="900" dirty="0"/>
              <a:t>Overview of the IgG Fc </a:t>
            </a:r>
            <a:r>
              <a:rPr lang="en-US" sz="900" dirty="0" err="1"/>
              <a:t>glycopeptides</a:t>
            </a:r>
            <a:r>
              <a:rPr lang="en-US" sz="900" dirty="0"/>
              <a:t> which were included after quality control. The monoisotopic m/z value of the 2+ and 3+ charge state are shown, together with the average retention time determined for all N-</a:t>
            </a:r>
            <a:r>
              <a:rPr lang="en-US" sz="900" dirty="0" err="1"/>
              <a:t>glycans</a:t>
            </a:r>
            <a:r>
              <a:rPr lang="en-US" sz="900" dirty="0"/>
              <a:t> of each IgG subclass. IgG1 </a:t>
            </a:r>
            <a:r>
              <a:rPr lang="en-US" sz="900" dirty="0" err="1"/>
              <a:t>glycopeptides</a:t>
            </a:r>
            <a:r>
              <a:rPr lang="en-US" sz="900" dirty="0"/>
              <a:t> contained the peptide sequence EEQYNSTYR, while IgG3 </a:t>
            </a:r>
            <a:r>
              <a:rPr lang="en-US" sz="900" dirty="0" err="1"/>
              <a:t>glycopeptides</a:t>
            </a:r>
            <a:r>
              <a:rPr lang="en-US" sz="900" dirty="0"/>
              <a:t> contained either the sequence EEQFNSTFR (denoted with *) or EEQFNSTYR (**). Glycan compositions are denoted using the following nomenclature: H = hexose, N = N-</a:t>
            </a:r>
            <a:r>
              <a:rPr lang="en-US" sz="900" dirty="0" err="1"/>
              <a:t>acetylhexosamine</a:t>
            </a:r>
            <a:r>
              <a:rPr lang="en-US" sz="900" dirty="0"/>
              <a:t>; F = </a:t>
            </a:r>
            <a:r>
              <a:rPr lang="en-US" sz="900" dirty="0" err="1"/>
              <a:t>fucose</a:t>
            </a:r>
            <a:r>
              <a:rPr lang="en-US" sz="900" dirty="0"/>
              <a:t>; S = sialic (N-</a:t>
            </a:r>
            <a:r>
              <a:rPr lang="en-US" sz="900" dirty="0" err="1"/>
              <a:t>acetylneuraminic</a:t>
            </a:r>
            <a:r>
              <a:rPr lang="en-US" sz="900" dirty="0"/>
              <a:t> acids</a:t>
            </a:r>
            <a:r>
              <a:rPr lang="en-US" sz="900" dirty="0" smtClean="0"/>
              <a:t>).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5544372"/>
              </p:ext>
            </p:extLst>
          </p:nvPr>
        </p:nvGraphicFramePr>
        <p:xfrm>
          <a:off x="560500" y="1244904"/>
          <a:ext cx="3825383" cy="9651696"/>
        </p:xfrm>
        <a:graphic>
          <a:graphicData uri="http://schemas.openxmlformats.org/drawingml/2006/table">
            <a:tbl>
              <a:tblPr/>
              <a:tblGrid>
                <a:gridCol w="1085190"/>
                <a:gridCol w="935669"/>
                <a:gridCol w="938676"/>
                <a:gridCol w="865848"/>
              </a:tblGrid>
              <a:tr h="114038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N-</a:t>
                      </a:r>
                      <a:r>
                        <a:rPr lang="nl-NL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glycopeptides</a:t>
                      </a:r>
                      <a:endParaRPr lang="nl-NL" sz="8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1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/z</a:t>
                      </a:r>
                      <a:r>
                        <a:rPr lang="nl-NL" sz="800" b="1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2+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1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/z</a:t>
                      </a:r>
                      <a:r>
                        <a:rPr lang="nl-NL" sz="800" b="1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3+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1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etention time (s)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855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3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17.5266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78.686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4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98.553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32.7044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79.5794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86.7220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6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60.605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40.7396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3N5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19.0663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46.3799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4N5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00.0927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00.3975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5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81.119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54.4151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6N3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04.613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70.078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4N4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44.1007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29.7362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4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25.127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3.753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6N4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706.1535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37.7714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4N5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45.6404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97.429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5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726.666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51.4470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4F1S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770.674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80.7856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3N4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44.4976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30.00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4N4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25.524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84.0184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4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06.5504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38.0361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3N5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46.0373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97.6940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4N5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27.0637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51.7116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5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08.090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05.7292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IgG1 </a:t>
                      </a:r>
                      <a:r>
                        <a:rPr lang="nl-NL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H6N5F0S0</a:t>
                      </a:r>
                      <a:endParaRPr lang="nl-NL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89.1165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59.746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4N4F0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71.0717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81.050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4F0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52.098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35.0679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5F0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53.637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02.7610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1 H5N4F0S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97.645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32.099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3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01.5317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68.0235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4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82.558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22.0411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63.5845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76.058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6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44.610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30.0764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3N5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03.0713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35.716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4N5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84.097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89.73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5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65.124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43.7519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6N3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88.618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59.4150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4N4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28.105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19.0729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4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09.132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73.0906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6N4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90.1586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27.1082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4N5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29.6455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6.7661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5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710.671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40.783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4F1S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754.679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70.1224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3N4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28.5027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19.3376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4N4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09.529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73.3552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4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90.5555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27.372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3N5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30.0424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87.030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4N5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11.068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41.048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653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5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92.095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95.0659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IgG3* </a:t>
                      </a:r>
                      <a:r>
                        <a:rPr lang="nl-NL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H6N5F0S0</a:t>
                      </a:r>
                      <a:endParaRPr lang="nl-NL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73.1216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49.0835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4N4F0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55.076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70.3870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4F0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36.103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24.4046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5F0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37.642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92.09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 H5N4F0S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81.650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21.4364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3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09.529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73.3552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4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90.5555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27.372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71.581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81.3904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6N4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52.6084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35.4080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3N5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11.0688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41.048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4N5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92.095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95.0659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5F1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73.1216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49.0835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6N3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96.6164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64.746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4N4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36.103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24.4046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4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17.1297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78.4222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6N4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98.156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32.439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4N5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37.642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92.0977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5F1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718.6693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46.115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4F1S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762.6774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75.4540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3N4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36.500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24.6692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4N4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17.5266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78.686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4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98.553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32.7044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3N5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338.0399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92.362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4N5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19.0663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46.3799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5F0S0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00.0927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00.3975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IgG3** </a:t>
                      </a:r>
                      <a:r>
                        <a:rPr lang="nl-NL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H6N5F0S0</a:t>
                      </a:r>
                      <a:endParaRPr lang="nl-NL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81.119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54.4151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4N4F0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463.0743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975.7186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4F0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544.1007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29.7362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3671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5F0S1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645.6404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97.4293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855"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gG3** H5N4F0S2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NA</a:t>
                      </a:r>
                    </a:p>
                  </a:txBody>
                  <a:tcPr marL="5076" marR="5076" marT="5076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26.7680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</a:t>
                      </a:r>
                    </a:p>
                  </a:txBody>
                  <a:tcPr marL="5076" marR="5076" marT="5076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94230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471488" y="649114"/>
            <a:ext cx="5915025" cy="6799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800" dirty="0"/>
              <a:t>Sonneveld et al. </a:t>
            </a:r>
            <a:r>
              <a:rPr lang="nl-NL" sz="1800" dirty="0" err="1"/>
              <a:t>Supplementary</a:t>
            </a:r>
            <a:r>
              <a:rPr lang="nl-NL" sz="1800" dirty="0"/>
              <a:t> </a:t>
            </a:r>
            <a:r>
              <a:rPr lang="nl-NL" sz="1800" dirty="0" err="1" smtClean="0"/>
              <a:t>table</a:t>
            </a:r>
            <a:r>
              <a:rPr lang="nl-NL" sz="1800" dirty="0" smtClean="0"/>
              <a:t> </a:t>
            </a:r>
            <a:r>
              <a:rPr lang="nl-NL" sz="1800" dirty="0"/>
              <a:t>2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3335301"/>
              </p:ext>
            </p:extLst>
          </p:nvPr>
        </p:nvGraphicFramePr>
        <p:xfrm>
          <a:off x="560499" y="1265866"/>
          <a:ext cx="5915025" cy="2530642"/>
        </p:xfrm>
        <a:graphic>
          <a:graphicData uri="http://schemas.openxmlformats.org/drawingml/2006/table">
            <a:tbl>
              <a:tblPr/>
              <a:tblGrid>
                <a:gridCol w="766594"/>
                <a:gridCol w="1565330"/>
                <a:gridCol w="3583101"/>
              </a:tblGrid>
              <a:tr h="202940"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rived</a:t>
                      </a:r>
                      <a:r>
                        <a:rPr lang="nl-NL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nl-NL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t</a:t>
                      </a:r>
                      <a:endParaRPr lang="nl-NL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inition</a:t>
                      </a:r>
                      <a:endParaRPr lang="nl-NL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culation</a:t>
                      </a:r>
                    </a:p>
                  </a:txBody>
                  <a:tcPr marL="4059" marR="4059" marT="4059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175"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cosylation</a:t>
                      </a: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of 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glycans which carry a core fucose</a:t>
                      </a: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3N4F1S0 + H4N4F1S0 + H5N4F1S0 + H6N4F1S0 + H3N5F1S0 + H4N5F1S0 + H5N5F1S0 + H6N3F1S1 + H4N4F1S1 + H5N4F1S1 + H6N4F1S1 + H4N5F1S1 + H5N5F1S1 + H5N4F1S2</a:t>
                      </a:r>
                    </a:p>
                  </a:txBody>
                  <a:tcPr marL="4059" marR="4059" marT="4059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53467"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actosylation</a:t>
                      </a: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of 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glycan antennae which carry a galactose</a:t>
                      </a: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* (H4N4F1S0 + H4N5F1S0 + H4N4F1S1 + H4N5F1S1 + H4N4F0S0 + H4N5F0S0 + H4N4F0S1 + </a:t>
                      </a:r>
                      <a:r>
                        <a:rPr lang="pt-B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6N4F1S0</a:t>
                      </a:r>
                      <a:r>
                        <a:rPr lang="pt-B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#</a:t>
                      </a:r>
                      <a:r>
                        <a:rPr lang="pt-B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 H6N3F1S1 + </a:t>
                      </a:r>
                      <a:r>
                        <a:rPr lang="pt-B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6N4F1S1 </a:t>
                      </a:r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</a:t>
                      </a:r>
                      <a:r>
                        <a:rPr lang="pt-BR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pt-B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H6N5F0S0#) </a:t>
                      </a:r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 1 * (H5N4F1S0 + H5N5F1S0 + H5N4F1S1 + H5N5F1S1 + H5N4F0S0 + H5N5F0S0 + H5N4F0S1 + H5N5F0S1 + H5N4F0S2)</a:t>
                      </a:r>
                    </a:p>
                  </a:txBody>
                  <a:tcPr marL="4059" marR="4059" marT="4059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644"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alylation</a:t>
                      </a: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of 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glycan antennae which carry an 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acetylneuraminic (sialic) acid</a:t>
                      </a: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* (H6N3F1S1 + H4N4F1S1 + H5N4F1S1 + H6N4F1S1 + H4N5F1S1 + H5N5F1S1 + H4N4F0S1 + H5N4F0S1 + H5N5F0S1) + 1 * (H5N4F1S2 + H5N4F0S2)</a:t>
                      </a:r>
                    </a:p>
                  </a:txBody>
                  <a:tcPr marL="4059" marR="4059" marT="4059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352"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section</a:t>
                      </a:r>
                      <a:endParaRPr lang="nl-NL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of 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ans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which carry a bisecting 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etylglucosami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3N5F1S0 + H4N5F1S0 + H5N5F1S0 + H4N5F1S1 + H5N5F1S1 + H3N5F0S0 + H4N5F0S0 + H5N5F0S0 + H5N5F0S1 + </a:t>
                      </a:r>
                      <a:r>
                        <a:rPr lang="pt-B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6N5F1S0</a:t>
                      </a:r>
                      <a:r>
                        <a:rPr lang="pt-B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# </a:t>
                      </a:r>
                      <a:r>
                        <a:rPr lang="pt-B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+ </a:t>
                      </a:r>
                      <a:r>
                        <a:rPr lang="pt-B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H6N4F1S1# </a:t>
                      </a:r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 </a:t>
                      </a:r>
                      <a:r>
                        <a:rPr lang="pt-B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H6N5F0S0#</a:t>
                      </a:r>
                      <a:endParaRPr lang="pt-B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59" marR="4059" marT="4059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84513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</a:t>
                      </a:r>
                      <a:r>
                        <a:rPr lang="en-US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is glycopeptide composition it was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biguous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ether the structure contained a galactose and whether it was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sected</a:t>
                      </a:r>
                      <a:endParaRPr lang="nl-NL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59" marR="4059" marT="4059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nl-NL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59" marR="4059" marT="4059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nl-NL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59" marR="4059" marT="4059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71487" y="3918394"/>
            <a:ext cx="59150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upplementary table </a:t>
            </a:r>
            <a:r>
              <a:rPr lang="en-US" sz="1100" b="1" dirty="0"/>
              <a:t>2  An overview of the calculations for the derived glycosylation </a:t>
            </a:r>
            <a:r>
              <a:rPr lang="en-US" sz="1100" b="1" dirty="0" smtClean="0"/>
              <a:t>traits</a:t>
            </a:r>
          </a:p>
        </p:txBody>
      </p:sp>
    </p:spTree>
    <p:extLst>
      <p:ext uri="{BB962C8B-B14F-4D97-AF65-F5344CB8AC3E}">
        <p14:creationId xmlns:p14="http://schemas.microsoft.com/office/powerpoint/2010/main" val="11776613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471488" y="649114"/>
            <a:ext cx="5915025" cy="6799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800" dirty="0"/>
              <a:t>Sonneveld et al. </a:t>
            </a:r>
            <a:r>
              <a:rPr lang="nl-NL" sz="1800" dirty="0" err="1"/>
              <a:t>Supplementary</a:t>
            </a:r>
            <a:r>
              <a:rPr lang="nl-NL" sz="1800" dirty="0"/>
              <a:t> </a:t>
            </a:r>
            <a:r>
              <a:rPr lang="nl-NL" sz="1800" dirty="0" err="1" smtClean="0"/>
              <a:t>table</a:t>
            </a:r>
            <a:r>
              <a:rPr lang="nl-NL" sz="1800" dirty="0" smtClean="0"/>
              <a:t> 3</a:t>
            </a:r>
            <a:endParaRPr lang="nl-NL" sz="1800" dirty="0"/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7644610"/>
              </p:ext>
            </p:extLst>
          </p:nvPr>
        </p:nvGraphicFramePr>
        <p:xfrm>
          <a:off x="539524" y="1526349"/>
          <a:ext cx="5915024" cy="5091285"/>
        </p:xfrm>
        <a:graphic>
          <a:graphicData uri="http://schemas.openxmlformats.org/drawingml/2006/table">
            <a:tbl>
              <a:tblPr/>
              <a:tblGrid>
                <a:gridCol w="587782"/>
                <a:gridCol w="942436"/>
                <a:gridCol w="942436"/>
                <a:gridCol w="724187"/>
                <a:gridCol w="704347"/>
                <a:gridCol w="1259888"/>
                <a:gridCol w="753948"/>
              </a:tblGrid>
              <a:tr h="163755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no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</a:t>
                      </a:r>
                      <a:r>
                        <a:rPr lang="nl-NL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gG1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</a:t>
                      </a:r>
                      <a:r>
                        <a:rPr lang="nl-NL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gG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 IgG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 IgG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G1 + IgG3 Concentration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ter (1:100)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6311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2-509920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6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3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CE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2-510424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4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2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181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7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2-511646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.94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9898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06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1174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6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3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CE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?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2-511904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14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B1B1B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86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C2C2C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2449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3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8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29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B0B0B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71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C3C3C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5959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.24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9898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76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?</a:t>
                      </a:r>
                      <a:endParaRPr lang="nl-NL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0183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46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B8B8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54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3200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94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181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6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4542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8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8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8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B8B8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2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10399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3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.99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A9A9A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01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CACA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10521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2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.36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A8A8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4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9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10859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14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B1B1B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86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C2C2C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?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3164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6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2E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91919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217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5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4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A0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?</a:t>
                      </a:r>
                      <a:endParaRPr lang="nl-NL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3309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6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B8B8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1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5001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.55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B4B4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45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4216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.4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8888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BEB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484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3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1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181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4747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85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94949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15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DFDF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1139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0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.0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C6C6C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4030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6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D8D8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3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4752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2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A2A2A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7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D1D1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219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0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95959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0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DEDE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0390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8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.91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C8C8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9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8792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0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A1A1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D2D2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7408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73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9E9E9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27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7278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.61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F8F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9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4E4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4387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28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A7A7A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72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3059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96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D8D8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04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8889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5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6868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7073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3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5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.74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87878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6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ECEC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8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6311"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11018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7443" marR="7443" marT="7443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4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0%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0</a:t>
                      </a:r>
                    </a:p>
                  </a:txBody>
                  <a:tcPr marL="7443" marR="7443" marT="7443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29995" y="10100770"/>
            <a:ext cx="59150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upplementary table 3 Sample information on (A) IgG1 and IgG3 concentrations and (</a:t>
            </a:r>
            <a:r>
              <a:rPr lang="en-US" sz="1100" b="1" dirty="0"/>
              <a:t>B) of women who gave birth to an antigen positive child. 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3882237"/>
              </p:ext>
            </p:extLst>
          </p:nvPr>
        </p:nvGraphicFramePr>
        <p:xfrm>
          <a:off x="529995" y="7001915"/>
          <a:ext cx="5924559" cy="2278858"/>
        </p:xfrm>
        <a:graphic>
          <a:graphicData uri="http://schemas.openxmlformats.org/drawingml/2006/table">
            <a:tbl>
              <a:tblPr/>
              <a:tblGrid>
                <a:gridCol w="388020"/>
                <a:gridCol w="154435"/>
                <a:gridCol w="239376"/>
                <a:gridCol w="239376"/>
                <a:gridCol w="208488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  <a:gridCol w="293429"/>
              </a:tblGrid>
              <a:tr h="30654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oto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f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body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K IgG3 </a:t>
                      </a:r>
                      <a:r>
                        <a:rPr lang="nl-NL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c</a:t>
                      </a:r>
                      <a:endParaRPr lang="nl-NL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K IgG3 gal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K IgG3 bis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K IgG3 sial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IgG3 fuc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IgG3 gal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IgG3 bis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IgG3 sial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K IgG1 fuc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K IgG1 gal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K IgG1 bis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K IgG1 sial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IgG1 fuc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IgG1 gal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IgG1 bis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IgG1 sial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21462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484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474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1101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9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039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438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421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403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475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2-50992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727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305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879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888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707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0740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3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3-51139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5678">
                <a:tc>
                  <a:txBody>
                    <a:bodyPr/>
                    <a:lstStyle/>
                    <a:p>
                      <a:pPr algn="l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4-50219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5784" marR="5784" marT="5784" marB="0" anchor="b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4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2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9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5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6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1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</a:t>
                      </a:r>
                    </a:p>
                  </a:txBody>
                  <a:tcPr marL="5784" marR="5784" marT="5784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8346055"/>
              </p:ext>
            </p:extLst>
          </p:nvPr>
        </p:nvGraphicFramePr>
        <p:xfrm>
          <a:off x="529995" y="9303104"/>
          <a:ext cx="5915029" cy="692404"/>
        </p:xfrm>
        <a:graphic>
          <a:graphicData uri="http://schemas.openxmlformats.org/drawingml/2006/table">
            <a:tbl>
              <a:tblPr firstRow="1" firstCol="1" bandRow="1"/>
              <a:tblGrid>
                <a:gridCol w="5915029"/>
              </a:tblGrid>
              <a:tr h="138049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8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Hb</a:t>
                      </a:r>
                      <a:r>
                        <a:rPr lang="nl-NL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= </a:t>
                      </a:r>
                      <a:r>
                        <a:rPr lang="nl-NL" sz="8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Hemoglobin</a:t>
                      </a:r>
                      <a:r>
                        <a:rPr lang="nl-NL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level (g/</a:t>
                      </a:r>
                      <a:r>
                        <a:rPr lang="nl-NL" sz="8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dL</a:t>
                      </a:r>
                      <a:r>
                        <a:rPr lang="nl-NL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)</a:t>
                      </a:r>
                      <a:endParaRPr lang="nl-NL" sz="800" b="0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54019" marR="540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8049"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err="1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Phtoto</a:t>
                      </a:r>
                      <a:r>
                        <a:rPr lang="en-US" sz="80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 =</a:t>
                      </a:r>
                      <a:r>
                        <a:rPr lang="en-US" sz="800" baseline="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 Phototherapy given to the newborn (1=yes, 2=no)</a:t>
                      </a:r>
                      <a:endParaRPr lang="en-US" sz="800" dirty="0" smtClean="0">
                        <a:effectLst/>
                        <a:latin typeface="+mn-lt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4019" marR="540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8049"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err="1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Transf</a:t>
                      </a:r>
                      <a:r>
                        <a:rPr lang="en-US" sz="800" baseline="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 = intrauterine or post-delivery blood transfusion given to the fetus or newborn</a:t>
                      </a:r>
                      <a:endParaRPr lang="en-US" sz="800" dirty="0" smtClean="0">
                        <a:effectLst/>
                        <a:latin typeface="+mn-lt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4019" marR="540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8049"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Antibody</a:t>
                      </a:r>
                      <a:r>
                        <a:rPr lang="en-US" sz="800" baseline="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 = Antibody level</a:t>
                      </a:r>
                      <a:endParaRPr lang="en-US" sz="800" dirty="0" smtClean="0">
                        <a:effectLst/>
                        <a:latin typeface="+mn-lt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4019" marR="540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8049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err="1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fuc</a:t>
                      </a:r>
                      <a:r>
                        <a:rPr lang="en-US" sz="80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 = </a:t>
                      </a:r>
                      <a:r>
                        <a:rPr lang="en-US" sz="800" dirty="0" err="1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fucosylation</a:t>
                      </a:r>
                      <a:r>
                        <a:rPr lang="en-US" sz="80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, gal = </a:t>
                      </a:r>
                      <a:r>
                        <a:rPr lang="en-US" sz="800" dirty="0" err="1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galactosylation</a:t>
                      </a:r>
                      <a:r>
                        <a:rPr lang="en-US" sz="80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800" dirty="0" err="1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bis</a:t>
                      </a:r>
                      <a:r>
                        <a:rPr lang="en-US" sz="800" baseline="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 = bisection, </a:t>
                      </a:r>
                      <a:r>
                        <a:rPr lang="en-US" sz="800" baseline="0" dirty="0" err="1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sial</a:t>
                      </a:r>
                      <a:r>
                        <a:rPr lang="en-US" sz="800" baseline="0" dirty="0" smtClean="0">
                          <a:effectLst/>
                          <a:latin typeface="+mn-lt"/>
                          <a:ea typeface="Calibri"/>
                          <a:cs typeface="Times New Roman" panose="02020603050405020304" pitchFamily="18" charset="0"/>
                        </a:rPr>
                        <a:t> = sialylation</a:t>
                      </a:r>
                      <a:endParaRPr lang="en-US" sz="800" dirty="0" smtClean="0">
                        <a:effectLst/>
                        <a:latin typeface="+mn-lt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4019" marR="540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itle 1"/>
          <p:cNvSpPr txBox="1">
            <a:spLocks/>
          </p:cNvSpPr>
          <p:nvPr/>
        </p:nvSpPr>
        <p:spPr>
          <a:xfrm>
            <a:off x="471488" y="1200290"/>
            <a:ext cx="312950" cy="3260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800" dirty="0"/>
              <a:t>A</a:t>
            </a: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471488" y="6675856"/>
            <a:ext cx="312950" cy="3260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8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9149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39BA629A07A9F4BB6847AA682F917A8" ma:contentTypeVersion="7" ma:contentTypeDescription="Create a new document." ma:contentTypeScope="" ma:versionID="35c4100408f23215276ca7fbb6584ace">
  <xsd:schema xmlns:xsd="http://www.w3.org/2001/XMLSchema" xmlns:p="http://schemas.microsoft.com/office/2006/metadata/properties" xmlns:ns2="f9200e2c-35ea-4398-940a-5106842a3e9c" targetNamespace="http://schemas.microsoft.com/office/2006/metadata/properties" ma:root="true" ma:fieldsID="0d936c70b851f96e272aa3eebb5db539" ns2:_="">
    <xsd:import namespace="f9200e2c-35ea-4398-940a-5106842a3e9c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9200e2c-35ea-4398-940a-5106842a3e9c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f9200e2c-35ea-4398-940a-5106842a3e9c">
      <UserInfo>
        <DisplayName/>
        <AccountId xsi:nil="true"/>
        <AccountType/>
      </UserInfo>
    </Checked_x0020_Out_x0020_To>
    <IsDeleted xmlns="f9200e2c-35ea-4398-940a-5106842a3e9c">false</IsDeleted>
    <FileFormat xmlns="f9200e2c-35ea-4398-940a-5106842a3e9c">PPTX</FileFormat>
    <TitleName xmlns="f9200e2c-35ea-4398-940a-5106842a3e9c">Presentation 1.PPTX</TitleName>
    <StageName xmlns="f9200e2c-35ea-4398-940a-5106842a3e9c" xsi:nil="true"/>
    <DocumentId xmlns="f9200e2c-35ea-4398-940a-5106842a3e9c">Presentation 1.PPTX</DocumentId>
    <DocumentType xmlns="f9200e2c-35ea-4398-940a-5106842a3e9c">Presentation</DocumentType>
  </documentManagement>
</p:properties>
</file>

<file path=customXml/itemProps1.xml><?xml version="1.0" encoding="utf-8"?>
<ds:datastoreItem xmlns:ds="http://schemas.openxmlformats.org/officeDocument/2006/customXml" ds:itemID="{461F5BEA-14DF-476C-8697-F51BC5A3FE63}"/>
</file>

<file path=customXml/itemProps2.xml><?xml version="1.0" encoding="utf-8"?>
<ds:datastoreItem xmlns:ds="http://schemas.openxmlformats.org/officeDocument/2006/customXml" ds:itemID="{82398FB7-A95A-4563-8D9F-ACE5813256A1}"/>
</file>

<file path=customXml/itemProps3.xml><?xml version="1.0" encoding="utf-8"?>
<ds:datastoreItem xmlns:ds="http://schemas.openxmlformats.org/officeDocument/2006/customXml" ds:itemID="{BC700BB2-F5A3-42B1-B6D7-629F0BC28365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56</TotalTime>
  <Words>1777</Words>
  <Application>Microsoft Office PowerPoint</Application>
  <PresentationFormat>Widescreen</PresentationFormat>
  <Paragraphs>944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rism 6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anqui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gG1 and IgG3 show different Fc-glycosylation for total serum and antigen-specific antibodies</dc:title>
  <dc:creator>Sonneveld, Myrthe</dc:creator>
  <cp:lastModifiedBy>Sonneveld, Myrthe</cp:lastModifiedBy>
  <cp:revision>72</cp:revision>
  <cp:lastPrinted>2017-04-12T06:25:58Z</cp:lastPrinted>
  <dcterms:created xsi:type="dcterms:W3CDTF">2017-02-14T15:06:24Z</dcterms:created>
  <dcterms:modified xsi:type="dcterms:W3CDTF">2017-09-04T09:26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39BA629A07A9F4BB6847AA682F917A8</vt:lpwstr>
  </property>
</Properties>
</file>